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12A76-E386-44E6-9AA6-9F761DE477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B54453-213B-41D3-A836-471F81FF8B0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FF11BF-2762-49E2-9B66-79D9DC4E3C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9A81A7-39C6-425A-95F4-F1400E3586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8EF428-8C58-4639-964A-DC617F4ABB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02C1C-21C6-4726-AC23-4D2B9F44A33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0FF22C-F9E4-4DE2-8C4A-030A9661BD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56D2CA-42EC-4090-8DBD-04A411E49F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328F4-8EFC-44A0-B4E5-1E5A1C6C8E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DD7E27-BFFD-4C46-99FA-0D12CF9FCA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335B8A-913B-4F82-8B68-48FF7C9608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5DDE1C-C924-472A-9D5A-07E58F4D50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140672-8CAB-4677-9CFF-AA656662D3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54160" y="1871640"/>
            <a:ext cx="8454960" cy="17690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dentity of 50 residues against human fragmen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  Sequences of phosphorylation sit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uma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S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impanzee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S-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nkey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90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S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Hors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2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L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6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IL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og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L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at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6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S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ous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6%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---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-TS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654640" y="763560"/>
            <a:ext cx="29070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upplementary data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729880" y="1290600"/>
            <a:ext cx="316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mino acid sequences alignment of BRCA2 frag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935520" y="3944880"/>
            <a:ext cx="227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</a:rPr>
              <a:t>418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s conserved in various mamma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11T07:41:20Z</dcterms:created>
  <dc:creator>s.bigmore</dc:creator>
  <dc:description/>
  <dc:language>en-US</dc:language>
  <cp:lastModifiedBy>s.bigmore</cp:lastModifiedBy>
  <dcterms:modified xsi:type="dcterms:W3CDTF">2008-09-11T07:49:15Z</dcterms:modified>
  <cp:revision>2</cp:revision>
  <dc:subject/>
  <dc:title>Slide 1</dc:title>
</cp:coreProperties>
</file>